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>
      <p:cViewPr varScale="1">
        <p:scale>
          <a:sx n="51" d="100"/>
          <a:sy n="51" d="100"/>
        </p:scale>
        <p:origin x="36" y="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00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7690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39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429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8276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442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804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8012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3616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656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915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82845-A5EE-45EE-AF18-563F92FA67EB}" type="datetimeFigureOut">
              <a:rPr kumimoji="1" lang="ja-JP" altLang="en-US" smtClean="0"/>
              <a:t>201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85000-E801-44D9-8BE3-AEC72E38E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076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4751" y="769715"/>
            <a:ext cx="7974498" cy="53185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71952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018" y="394062"/>
            <a:ext cx="8705964" cy="6069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51835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534" y="41269"/>
            <a:ext cx="8990931" cy="67754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55937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443" y="63366"/>
            <a:ext cx="8843114" cy="67312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150948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916" y="33649"/>
            <a:ext cx="8974168" cy="67907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832968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166" y="190616"/>
            <a:ext cx="8495667" cy="6476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88984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2" y="301102"/>
            <a:ext cx="9141795" cy="6255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122092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204" y="339200"/>
            <a:ext cx="8873591" cy="6179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367887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305" y="294244"/>
            <a:ext cx="8669390" cy="6269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1606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967" y="267575"/>
            <a:ext cx="8840066" cy="6322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7692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923" y="757523"/>
            <a:ext cx="8686153" cy="53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2241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779" y="757523"/>
            <a:ext cx="8736441" cy="53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4156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162" y="757523"/>
            <a:ext cx="8655675" cy="53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00147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590" y="757523"/>
            <a:ext cx="8664819" cy="53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72065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590" y="757523"/>
            <a:ext cx="8664819" cy="53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47190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113" y="757523"/>
            <a:ext cx="8725774" cy="53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92849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257" y="363584"/>
            <a:ext cx="8675486" cy="6130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4044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0</Words>
  <Application>Microsoft Office PowerPoint</Application>
  <PresentationFormat>画面に合わせる (4:3)</PresentationFormat>
  <Paragraphs>0</Paragraphs>
  <Slides>1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7</vt:i4>
      </vt:variant>
    </vt:vector>
  </HeadingPairs>
  <TitlesOfParts>
    <vt:vector size="22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isobe</dc:creator>
  <cp:lastModifiedBy>sisobe</cp:lastModifiedBy>
  <cp:revision>3</cp:revision>
  <dcterms:created xsi:type="dcterms:W3CDTF">2015-02-11T04:51:28Z</dcterms:created>
  <dcterms:modified xsi:type="dcterms:W3CDTF">2015-02-11T05:10:10Z</dcterms:modified>
</cp:coreProperties>
</file>